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C98562-169A-4873-A21F-02AAE6C575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98EE70-6784-4AE2-9C30-D24B21D9DE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EBD560-0DAC-41E7-BF2C-655E0C7EB14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BBAC3A-5F74-426B-8B49-885911880D3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CA8511-F067-4F16-8BD0-FFA967B782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6F83DB-E94C-407D-A9DD-39C56955CE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F4955A-5BDC-4EE3-8ABD-574D46065B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23226D-3FD4-45BB-9255-70A3A7C0DF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6BBC6F-BAE4-4E42-86DF-8580CFF9EC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2AC59-384A-424D-9D45-E1BA44D606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33FF21-98F1-4CCD-ABDF-6840C72EAB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360EDD-F4A2-4E90-9AE4-0D42224695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0924C9-95FA-408D-BED3-E59F2CBA055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9144000" cy="304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PPENDIX C. Change from Baseline in MADRS Total Score by Assessment Visit (MMRM, FAS, LS Means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hart 8" descr=""/>
          <p:cNvPicPr/>
          <p:nvPr/>
        </p:nvPicPr>
        <p:blipFill>
          <a:blip r:embed="rId1"/>
          <a:stretch/>
        </p:blipFill>
        <p:spPr>
          <a:xfrm>
            <a:off x="0" y="639720"/>
            <a:ext cx="7772400" cy="518148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3" name=""/>
          <p:cNvGraphicFramePr/>
          <p:nvPr/>
        </p:nvGraphicFramePr>
        <p:xfrm>
          <a:off x="0" y="5791320"/>
          <a:ext cx="8790120" cy="533160"/>
        </p:xfrm>
        <a:graphic>
          <a:graphicData uri="http://schemas.openxmlformats.org/drawingml/2006/table">
            <a:tbl>
              <a:tblPr/>
              <a:tblGrid>
                <a:gridCol w="1066680"/>
                <a:gridCol w="762120"/>
                <a:gridCol w="816120"/>
                <a:gridCol w="679320"/>
                <a:gridCol w="866880"/>
                <a:gridCol w="720720"/>
                <a:gridCol w="541080"/>
                <a:gridCol w="727200"/>
                <a:gridCol w="449280"/>
                <a:gridCol w="712800"/>
                <a:gridCol w="658800"/>
                <a:gridCol w="789120"/>
              </a:tblGrid>
              <a:tr h="168120">
                <a:tc>
                  <a:txBody>
                    <a:bodyPr lIns="18288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lacebo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828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=16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=16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=16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=16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=16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18288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ortioxetin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828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=17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=17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=17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=16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=17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18288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uloxetin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828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=18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=18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=18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=17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=18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44" name="Group 16"/>
          <p:cNvGrpSpPr/>
          <p:nvPr/>
        </p:nvGrpSpPr>
        <p:grpSpPr>
          <a:xfrm>
            <a:off x="0" y="1884240"/>
            <a:ext cx="9144000" cy="4973760"/>
            <a:chOff x="0" y="1884240"/>
            <a:chExt cx="9144000" cy="4973760"/>
          </a:xfrm>
        </p:grpSpPr>
        <p:sp>
          <p:nvSpPr>
            <p:cNvPr id="45" name="Title 6"/>
            <p:cNvSpPr/>
            <p:nvPr/>
          </p:nvSpPr>
          <p:spPr>
            <a:xfrm>
              <a:off x="0" y="6553440"/>
              <a:ext cx="9144000" cy="304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&lt;0.05, **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&lt;0.01, ***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&lt;0.001 vs. placeb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4"/>
            <p:cNvSpPr/>
            <p:nvPr/>
          </p:nvSpPr>
          <p:spPr>
            <a:xfrm>
              <a:off x="7854480" y="5108400"/>
              <a:ext cx="730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CF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Rectangle 5"/>
            <p:cNvSpPr/>
            <p:nvPr/>
          </p:nvSpPr>
          <p:spPr>
            <a:xfrm>
              <a:off x="8147520" y="4160880"/>
              <a:ext cx="137160" cy="136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Oval 7"/>
            <p:cNvSpPr/>
            <p:nvPr/>
          </p:nvSpPr>
          <p:spPr>
            <a:xfrm>
              <a:off x="8138160" y="3484080"/>
              <a:ext cx="152280" cy="152280"/>
            </a:xfrm>
            <a:prstGeom prst="ellipse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Isosceles Triangle 9"/>
            <p:cNvSpPr/>
            <p:nvPr/>
          </p:nvSpPr>
          <p:spPr>
            <a:xfrm>
              <a:off x="8147520" y="4343760"/>
              <a:ext cx="152280" cy="164520"/>
            </a:xfrm>
            <a:prstGeom prst="triangle">
              <a:avLst>
                <a:gd name="adj" fmla="val 50000"/>
              </a:avLst>
            </a:prstGeom>
            <a:solidFill>
              <a:srgbClr val="a6a6a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920" bIns="79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0"/>
            <p:cNvSpPr/>
            <p:nvPr/>
          </p:nvSpPr>
          <p:spPr>
            <a:xfrm>
              <a:off x="7373520" y="4554000"/>
              <a:ext cx="418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a6a6a6"/>
                  </a:solidFill>
                  <a:latin typeface="Arial"/>
                  <a:ea typeface="Arial"/>
                </a:rPr>
                <a:t>**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12"/>
            <p:cNvSpPr/>
            <p:nvPr/>
          </p:nvSpPr>
          <p:spPr>
            <a:xfrm>
              <a:off x="4236840" y="3584880"/>
              <a:ext cx="418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a6a6a6"/>
                  </a:solidFill>
                  <a:latin typeface="Arial"/>
                  <a:ea typeface="Arial"/>
                </a:rPr>
                <a:t>**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3"/>
            <p:cNvSpPr/>
            <p:nvPr/>
          </p:nvSpPr>
          <p:spPr>
            <a:xfrm>
              <a:off x="1968120" y="188424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a6a6a6"/>
                  </a:solidFill>
                  <a:latin typeface="Arial"/>
                  <a:ea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14"/>
            <p:cNvSpPr/>
            <p:nvPr/>
          </p:nvSpPr>
          <p:spPr>
            <a:xfrm>
              <a:off x="7445520" y="399924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15"/>
            <p:cNvSpPr/>
            <p:nvPr/>
          </p:nvSpPr>
          <p:spPr>
            <a:xfrm>
              <a:off x="4273200" y="2926440"/>
              <a:ext cx="339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3-11T20:03:24Z</dcterms:created>
  <dc:creator>Nicole Coolbaugh</dc:creator>
  <dc:description/>
  <dc:language>en-US</dc:language>
  <cp:lastModifiedBy>Satish D</cp:lastModifiedBy>
  <dcterms:modified xsi:type="dcterms:W3CDTF">2015-03-31T16:09:10Z</dcterms:modified>
  <cp:revision>20</cp:revision>
  <dc:subject/>
  <dc:title>APPENDIX C. Change from Baseline in MADRS Total Score by Assessment Visit (MMRM, FAS, LS Means)</dc:title>
</cp:coreProperties>
</file>